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0"/>
    <p:restoredTop sz="95884"/>
  </p:normalViewPr>
  <p:slideViewPr>
    <p:cSldViewPr snapToGrid="0" snapToObjects="1">
      <p:cViewPr varScale="1">
        <p:scale>
          <a:sx n="108" d="100"/>
          <a:sy n="108" d="100"/>
        </p:scale>
        <p:origin x="736" y="1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/>
              <a:t>Haga clic para modific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962111-62C8-4F46-A23C-5A1E759499BC}" type="datetimeFigureOut">
              <a:rPr lang="es-ES" smtClean="0"/>
              <a:t>2/2/21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9389EB-74D0-7A42-879B-9A80BDF5E2DC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37273999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962111-62C8-4F46-A23C-5A1E759499BC}" type="datetimeFigureOut">
              <a:rPr lang="es-ES" smtClean="0"/>
              <a:t>2/2/21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9389EB-74D0-7A42-879B-9A80BDF5E2DC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63393953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962111-62C8-4F46-A23C-5A1E759499BC}" type="datetimeFigureOut">
              <a:rPr lang="es-ES" smtClean="0"/>
              <a:t>2/2/21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9389EB-74D0-7A42-879B-9A80BDF5E2DC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60165555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962111-62C8-4F46-A23C-5A1E759499BC}" type="datetimeFigureOut">
              <a:rPr lang="es-ES" smtClean="0"/>
              <a:t>2/2/21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9389EB-74D0-7A42-879B-9A80BDF5E2DC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6282376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962111-62C8-4F46-A23C-5A1E759499BC}" type="datetimeFigureOut">
              <a:rPr lang="es-ES" smtClean="0"/>
              <a:t>2/2/21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9389EB-74D0-7A42-879B-9A80BDF5E2DC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53263841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962111-62C8-4F46-A23C-5A1E759499BC}" type="datetimeFigureOut">
              <a:rPr lang="es-ES" smtClean="0"/>
              <a:t>2/2/21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9389EB-74D0-7A42-879B-9A80BDF5E2DC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71884432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962111-62C8-4F46-A23C-5A1E759499BC}" type="datetimeFigureOut">
              <a:rPr lang="es-ES" smtClean="0"/>
              <a:t>2/2/21</a:t>
            </a:fld>
            <a:endParaRPr lang="es-E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9389EB-74D0-7A42-879B-9A80BDF5E2DC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17695501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962111-62C8-4F46-A23C-5A1E759499BC}" type="datetimeFigureOut">
              <a:rPr lang="es-ES" smtClean="0"/>
              <a:t>2/2/21</a:t>
            </a:fld>
            <a:endParaRPr lang="es-E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9389EB-74D0-7A42-879B-9A80BDF5E2DC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50092876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962111-62C8-4F46-A23C-5A1E759499BC}" type="datetimeFigureOut">
              <a:rPr lang="es-ES" smtClean="0"/>
              <a:t>2/2/21</a:t>
            </a:fld>
            <a:endParaRPr lang="es-E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9389EB-74D0-7A42-879B-9A80BDF5E2DC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69388627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962111-62C8-4F46-A23C-5A1E759499BC}" type="datetimeFigureOut">
              <a:rPr lang="es-ES" smtClean="0"/>
              <a:t>2/2/21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9389EB-74D0-7A42-879B-9A80BDF5E2DC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10240206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s-ES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962111-62C8-4F46-A23C-5A1E759499BC}" type="datetimeFigureOut">
              <a:rPr lang="es-ES" smtClean="0"/>
              <a:t>2/2/21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9389EB-74D0-7A42-879B-9A80BDF5E2DC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41441197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0962111-62C8-4F46-A23C-5A1E759499BC}" type="datetimeFigureOut">
              <a:rPr lang="es-ES" smtClean="0"/>
              <a:t>2/2/21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09389EB-74D0-7A42-879B-9A80BDF5E2DC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21697320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Imagen 2">
            <a:extLst>
              <a:ext uri="{FF2B5EF4-FFF2-40B4-BE49-F238E27FC236}">
                <a16:creationId xmlns:a16="http://schemas.microsoft.com/office/drawing/2014/main" id="{2F7C1939-F64E-DF47-B8E8-2ED326DD0F6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46100" y="1085850"/>
            <a:ext cx="11099800" cy="4686300"/>
          </a:xfrm>
          <a:prstGeom prst="rect">
            <a:avLst/>
          </a:prstGeom>
        </p:spPr>
      </p:pic>
      <p:sp>
        <p:nvSpPr>
          <p:cNvPr id="4" name="2 CuadroTexto">
            <a:extLst>
              <a:ext uri="{FF2B5EF4-FFF2-40B4-BE49-F238E27FC236}">
                <a16:creationId xmlns:a16="http://schemas.microsoft.com/office/drawing/2014/main" id="{31D53C23-21C9-3B48-BA3D-9B4EBB50A295}"/>
              </a:ext>
            </a:extLst>
          </p:cNvPr>
          <p:cNvSpPr txBox="1"/>
          <p:nvPr/>
        </p:nvSpPr>
        <p:spPr>
          <a:xfrm>
            <a:off x="998141" y="5633650"/>
            <a:ext cx="1076651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/>
              <a:t>Supplementary Figure 1</a:t>
            </a:r>
            <a:r>
              <a:rPr lang="en-GB" sz="1200" dirty="0"/>
              <a:t>.  Frequency of the different </a:t>
            </a:r>
            <a:r>
              <a:rPr lang="el-GR" sz="1200" dirty="0"/>
              <a:t>α-</a:t>
            </a:r>
            <a:r>
              <a:rPr lang="en-GB" sz="1200" dirty="0"/>
              <a:t>gliadin amplicon variants. </a:t>
            </a:r>
            <a:r>
              <a:rPr lang="en-GB" sz="1200"/>
              <a:t>Amplicons followed by an asterisk are pseudogenes.</a:t>
            </a:r>
            <a:endParaRPr lang="en-GB" sz="1200" dirty="0"/>
          </a:p>
        </p:txBody>
      </p:sp>
    </p:spTree>
    <p:extLst>
      <p:ext uri="{BB962C8B-B14F-4D97-AF65-F5344CB8AC3E}">
        <p14:creationId xmlns:p14="http://schemas.microsoft.com/office/powerpoint/2010/main" val="2075506167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7</TotalTime>
  <Words>21</Words>
  <Application>Microsoft Macintosh PowerPoint</Application>
  <PresentationFormat>Panorámica</PresentationFormat>
  <Paragraphs>1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ema de Office</vt:lpstr>
      <vt:lpstr>Presentación de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Francisco Barro</dc:creator>
  <cp:lastModifiedBy>Alberto Romero</cp:lastModifiedBy>
  <cp:revision>8</cp:revision>
  <dcterms:created xsi:type="dcterms:W3CDTF">2019-12-26T08:38:54Z</dcterms:created>
  <dcterms:modified xsi:type="dcterms:W3CDTF">2021-02-02T13:03:16Z</dcterms:modified>
</cp:coreProperties>
</file>